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65" d="100"/>
          <a:sy n="165" d="100"/>
        </p:scale>
        <p:origin x="120" y="4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135738-BCC4-435F-AFD5-5EDCC710826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DEF27B-DE6D-4E3B-98EF-FB7D4AC0808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D49CD50-9C80-46F9-AFEF-0342F7A6B6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367E134-1770-49C6-B6FF-A63A2C9562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081B0F6-75D6-4E3A-AD01-E3A39AD8E7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23820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51224E1-FFD3-432A-9269-46E74D73847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41E352B-27E0-4823-92BF-4B5FE506560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DDA2FD-253A-4DBB-8A4D-2B2600FC3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5806CF-333D-438A-8D1E-8D931B6C83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F557887-3E97-4353-A123-28B35358A00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772448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E218913-737E-4FE9-80A8-A498731729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16A2EB0-5820-4C54-A1E4-5060308FB89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2719275-2311-4C97-9C8A-60665DB5BA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87B7E47-AB1B-4A4E-A691-92B2CBB988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C5F1CA-7DC7-4C63-B525-76A925D580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95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A19D52C-22D8-413C-B7A9-D64A04F89AE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47E9281-31D4-4481-9509-324290671C4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BFD4096-5FD5-4F06-90F2-1BE8A3C3FA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3691B2-CF0E-43A4-A941-D7C5AF17C0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9C00FF-DD71-4FB6-9D44-96CE63EEFE6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586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C5CE40-CD69-4689-9148-D3AED6FAFB1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D6AA7D-7FA9-4654-A597-ED7F521B86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688EF8-711A-4F48-95F4-5C6835A1DE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ABCED50-C302-4664-8D82-C27DEC7FC3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AA0806-7642-4DDF-A810-431A37109B3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5481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CAA98B8-AFB8-4ED3-9FF8-DED6E87B75B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81C5095-D908-48CF-AE9F-47BF8794DA1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436A72A-020E-4630-ADDF-BD21458E7FD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612B0F-24ED-4A30-96AC-0F41C0BAFE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9A8211-7C9B-4543-8E7E-18CF4444A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18E08B-3EEA-4683-BF5F-F523F48C09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42569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A6985F6-9DE9-45BF-8283-15AAFC10BC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709EF2B-5440-4BC1-821D-312F315E33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701693F-6396-49C6-996B-30E0BF82973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FE9CCC5-3EF8-4C46-BEDD-F9D7270EE855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D84A91-0BE1-4844-8245-07C5BE5F11D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687FA0D-C5F1-44AA-84F5-B516AC3D5D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5D51586-3FAB-4B49-8F92-7FC14E889E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ABBA84B-68A1-4A35-B9A9-5080511AC4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74034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58EE9B-2BC6-410C-970C-4C412B6554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F14BE83-C285-4D27-A6D5-A1CFB500E3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8573278-E731-4442-AEA8-C44AC33DD5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F8BE6F-8FFF-4439-9488-3018A99884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462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7363D6-55C6-47AE-A46D-F2DD573F2D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9129B7E-EE93-4C5A-89FA-297E2EC742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9DDB2E-DAF8-47BE-A2D1-57F4619868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586271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B6AEA1-CE7E-49FF-9B98-756BE282DCA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E5AC7E-10D9-4756-9667-E9163840EE0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87278A3-7766-4ECC-8AB9-E52F2EB68F4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D141B83-CF7F-41EB-BFC5-A0D6AF1042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F2FCC4-BCBB-49E0-A893-AD3A850879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4AC5CF3-33B5-4BD0-A639-7BCB2994A1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56231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CCF2AC-75B7-46B3-8477-FD42202A81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9D0D090-1EE4-41F5-8F4D-D0C4F6B5C1F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1ED14E-136E-44DF-B3C8-8838343AA54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EDC549-48AC-440A-92DC-C8D8FC9C14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449BB7-B0FF-49CA-91C2-D0A2D6307E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1EB8848-EE52-4630-AE2B-4CB3A7A23F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348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92F6D72-57E9-43AD-AFA9-E9F3B57345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8FA5986-9421-46F5-97A1-3DD6123760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19924C4-9B98-46D1-9DEA-A4F20FF40AE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D7F93B-29CC-41A2-91DB-035123E12210}" type="datetimeFigureOut">
              <a:rPr lang="en-US" smtClean="0"/>
              <a:t>9/2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681AA3C-6412-4F44-87DD-B6E3C9F20DE1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22F02D-08B6-4FD9-826D-1C811E849EF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7B723-5325-493D-918A-E6E6D27EA9C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01499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2" name="Group 41">
            <a:extLst>
              <a:ext uri="{FF2B5EF4-FFF2-40B4-BE49-F238E27FC236}">
                <a16:creationId xmlns:a16="http://schemas.microsoft.com/office/drawing/2014/main" id="{0EADAD35-9C20-40BD-B47F-0D27A2CF14A8}"/>
              </a:ext>
            </a:extLst>
          </p:cNvPr>
          <p:cNvGrpSpPr/>
          <p:nvPr/>
        </p:nvGrpSpPr>
        <p:grpSpPr>
          <a:xfrm>
            <a:off x="1095377" y="914003"/>
            <a:ext cx="10387945" cy="2073897"/>
            <a:chOff x="1095375" y="914400"/>
            <a:chExt cx="10387945" cy="3457575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34D37C7-E045-49F1-B7B3-A674E55685C9}"/>
                </a:ext>
              </a:extLst>
            </p:cNvPr>
            <p:cNvSpPr/>
            <p:nvPr/>
          </p:nvSpPr>
          <p:spPr>
            <a:xfrm>
              <a:off x="1095375" y="914400"/>
              <a:ext cx="464761" cy="345757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9134D72B-66AF-4E0E-9996-812574ADE04E}"/>
                </a:ext>
              </a:extLst>
            </p:cNvPr>
            <p:cNvSpPr/>
            <p:nvPr/>
          </p:nvSpPr>
          <p:spPr>
            <a:xfrm>
              <a:off x="1095376" y="914400"/>
              <a:ext cx="816789" cy="3457575"/>
            </a:xfrm>
            <a:prstGeom prst="rect">
              <a:avLst/>
            </a:prstGeom>
            <a:solidFill>
              <a:schemeClr val="accent2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b="1" dirty="0">
                <a:solidFill>
                  <a:schemeClr val="tx1"/>
                </a:solidFill>
              </a:endParaRPr>
            </a:p>
            <a:p>
              <a:pPr algn="ctr"/>
              <a:r>
                <a:rPr lang="en-US" b="1" dirty="0" err="1">
                  <a:solidFill>
                    <a:schemeClr val="tx1"/>
                  </a:solidFill>
                </a:rPr>
                <a:t>adjY</a:t>
              </a:r>
              <a:endParaRPr lang="en-US" b="1" dirty="0">
                <a:solidFill>
                  <a:schemeClr val="tx1"/>
                </a:solidFill>
              </a:endParaRPr>
            </a:p>
            <a:p>
              <a:pPr algn="ctr"/>
              <a:endParaRPr lang="en-US" b="1" dirty="0">
                <a:solidFill>
                  <a:schemeClr val="tx1"/>
                </a:solidFill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6B6881FD-1226-4746-A510-2A3D0333C980}"/>
                </a:ext>
              </a:extLst>
            </p:cNvPr>
            <p:cNvSpPr/>
            <p:nvPr/>
          </p:nvSpPr>
          <p:spPr>
            <a:xfrm>
              <a:off x="1913641" y="914400"/>
              <a:ext cx="1965195" cy="3457575"/>
            </a:xfrm>
            <a:prstGeom prst="rect">
              <a:avLst/>
            </a:prstGeom>
            <a:solidFill>
              <a:schemeClr val="accent1">
                <a:lumMod val="20000"/>
                <a:lumOff val="8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covariates</a:t>
              </a:r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D79519AF-D574-46B8-A0C0-B15260CDAD90}"/>
                </a:ext>
              </a:extLst>
            </p:cNvPr>
            <p:cNvSpPr/>
            <p:nvPr/>
          </p:nvSpPr>
          <p:spPr>
            <a:xfrm>
              <a:off x="3878836" y="914400"/>
              <a:ext cx="4067961" cy="3457575"/>
            </a:xfrm>
            <a:prstGeom prst="rect">
              <a:avLst/>
            </a:prstGeom>
            <a:solidFill>
              <a:schemeClr val="accent6">
                <a:lumMod val="40000"/>
                <a:lumOff val="60000"/>
              </a:schemeClr>
            </a:solidFill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features (the typical X in classic TPOT)</a:t>
              </a:r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0F87F026-97E4-4F77-8FC6-B57B3249A327}"/>
                </a:ext>
              </a:extLst>
            </p:cNvPr>
            <p:cNvGrpSpPr/>
            <p:nvPr/>
          </p:nvGrpSpPr>
          <p:grpSpPr>
            <a:xfrm>
              <a:off x="7946797" y="914400"/>
              <a:ext cx="707009" cy="3457575"/>
              <a:chOff x="8729221" y="914400"/>
              <a:chExt cx="923826" cy="3457575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9813E101-471B-4EE1-A187-C27D172D9487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907D4296-E307-4627-9010-5540ECA91338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10130C6C-2974-43B1-BC56-7FD43B994DBB}"/>
                </a:ext>
              </a:extLst>
            </p:cNvPr>
            <p:cNvGrpSpPr/>
            <p:nvPr/>
          </p:nvGrpSpPr>
          <p:grpSpPr>
            <a:xfrm>
              <a:off x="8653807" y="914400"/>
              <a:ext cx="707009" cy="3457575"/>
              <a:chOff x="8729221" y="914400"/>
              <a:chExt cx="923826" cy="3457575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512FF140-2022-4FD9-8CAF-0DF1BCAD7989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98E2BA4D-C83A-41A0-A8CF-EDF4A397FA27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9454066F-6D74-4DE6-8AB6-FC2FC3A2FF91}"/>
                </a:ext>
              </a:extLst>
            </p:cNvPr>
            <p:cNvGrpSpPr/>
            <p:nvPr/>
          </p:nvGrpSpPr>
          <p:grpSpPr>
            <a:xfrm>
              <a:off x="9360817" y="914400"/>
              <a:ext cx="707009" cy="3457575"/>
              <a:chOff x="8729221" y="914400"/>
              <a:chExt cx="923826" cy="3457575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36FBC71C-98FC-472F-961D-C692E085344B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1D6CBDBC-1353-4AE8-B555-25C430D74703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B4F08563-78F4-4BA4-A130-E40DDBD506ED}"/>
                </a:ext>
              </a:extLst>
            </p:cNvPr>
            <p:cNvGrpSpPr/>
            <p:nvPr/>
          </p:nvGrpSpPr>
          <p:grpSpPr>
            <a:xfrm>
              <a:off x="10067827" y="914400"/>
              <a:ext cx="707009" cy="3457575"/>
              <a:chOff x="8729221" y="914400"/>
              <a:chExt cx="923826" cy="3457575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C4E11BF0-8D6A-49CC-B253-11D1251928DD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183DF0C2-5852-4605-BE06-7E586D47919D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C92460A2-4893-41AD-91A6-99D1D203BF3D}"/>
                </a:ext>
              </a:extLst>
            </p:cNvPr>
            <p:cNvGrpSpPr/>
            <p:nvPr/>
          </p:nvGrpSpPr>
          <p:grpSpPr>
            <a:xfrm>
              <a:off x="10776311" y="914400"/>
              <a:ext cx="707009" cy="3457575"/>
              <a:chOff x="8729221" y="914400"/>
              <a:chExt cx="923826" cy="3457575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0F93E1E5-3864-460E-AA5F-CABAF1C196BA}"/>
                  </a:ext>
                </a:extLst>
              </p:cNvPr>
              <p:cNvSpPr/>
              <p:nvPr/>
            </p:nvSpPr>
            <p:spPr>
              <a:xfrm>
                <a:off x="8729221" y="914400"/>
                <a:ext cx="461913" cy="3457575"/>
              </a:xfrm>
              <a:prstGeom prst="rect">
                <a:avLst/>
              </a:prstGeom>
              <a:solidFill>
                <a:schemeClr val="accent4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262C6E94-10C5-44A7-8C73-39CCAB0B8A5B}"/>
                  </a:ext>
                </a:extLst>
              </p:cNvPr>
              <p:cNvSpPr/>
              <p:nvPr/>
            </p:nvSpPr>
            <p:spPr>
              <a:xfrm>
                <a:off x="9191134" y="914400"/>
                <a:ext cx="461913" cy="3457575"/>
              </a:xfrm>
              <a:prstGeom prst="rect">
                <a:avLst/>
              </a:prstGeom>
              <a:solidFill>
                <a:schemeClr val="accent6"/>
              </a:solidFill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</p:grpSp>
      <p:sp>
        <p:nvSpPr>
          <p:cNvPr id="48" name="TextBox 47">
            <a:extLst>
              <a:ext uri="{FF2B5EF4-FFF2-40B4-BE49-F238E27FC236}">
                <a16:creationId xmlns:a16="http://schemas.microsoft.com/office/drawing/2014/main" id="{62FD3C16-D962-4A8E-877D-6E34C2404960}"/>
              </a:ext>
            </a:extLst>
          </p:cNvPr>
          <p:cNvSpPr txBox="1"/>
          <p:nvPr/>
        </p:nvSpPr>
        <p:spPr>
          <a:xfrm>
            <a:off x="617312" y="3559512"/>
            <a:ext cx="2312493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Target pre-adjusted to </a:t>
            </a:r>
          </a:p>
          <a:p>
            <a:r>
              <a:rPr lang="en-US" dirty="0"/>
              <a:t>the full data set, only </a:t>
            </a:r>
          </a:p>
          <a:p>
            <a:r>
              <a:rPr lang="en-US" dirty="0"/>
              <a:t>used for the final </a:t>
            </a:r>
          </a:p>
          <a:p>
            <a:r>
              <a:rPr lang="en-US"/>
              <a:t>score</a:t>
            </a:r>
            <a:endParaRPr lang="en-US" dirty="0"/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3227C8F8-3E02-48DD-809B-AFE6BF614ABC}"/>
              </a:ext>
            </a:extLst>
          </p:cNvPr>
          <p:cNvCxnSpPr>
            <a:cxnSpLocks/>
            <a:stCxn id="9" idx="2"/>
          </p:cNvCxnSpPr>
          <p:nvPr/>
        </p:nvCxnSpPr>
        <p:spPr>
          <a:xfrm>
            <a:off x="2896241" y="2987900"/>
            <a:ext cx="12490" cy="2914619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5BE4A134-EFB2-4A68-85EE-015535E5D47E}"/>
              </a:ext>
            </a:extLst>
          </p:cNvPr>
          <p:cNvSpPr txBox="1"/>
          <p:nvPr/>
        </p:nvSpPr>
        <p:spPr>
          <a:xfrm>
            <a:off x="416573" y="5948313"/>
            <a:ext cx="47433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ovariates needed by </a:t>
            </a:r>
            <a:r>
              <a:rPr lang="en-US" i="1" dirty="0" err="1"/>
              <a:t>resAdjTransformer</a:t>
            </a:r>
            <a:r>
              <a:rPr lang="en-US" dirty="0"/>
              <a:t>, if any,</a:t>
            </a:r>
          </a:p>
          <a:p>
            <a:r>
              <a:rPr lang="en-US" dirty="0"/>
              <a:t>to be removed by </a:t>
            </a:r>
            <a:r>
              <a:rPr lang="en-US" i="1" dirty="0" err="1"/>
              <a:t>resAdjTransformer</a:t>
            </a:r>
            <a:r>
              <a:rPr lang="en-US" dirty="0"/>
              <a:t> after use</a:t>
            </a:r>
          </a:p>
        </p:txBody>
      </p:sp>
      <p:cxnSp>
        <p:nvCxnSpPr>
          <p:cNvPr id="53" name="Straight Arrow Connector 52">
            <a:extLst>
              <a:ext uri="{FF2B5EF4-FFF2-40B4-BE49-F238E27FC236}">
                <a16:creationId xmlns:a16="http://schemas.microsoft.com/office/drawing/2014/main" id="{4C711A10-B555-4C4C-A0D2-94BB1D5FADBA}"/>
              </a:ext>
            </a:extLst>
          </p:cNvPr>
          <p:cNvCxnSpPr>
            <a:stCxn id="10" idx="2"/>
          </p:cNvCxnSpPr>
          <p:nvPr/>
        </p:nvCxnSpPr>
        <p:spPr>
          <a:xfrm flipH="1">
            <a:off x="5912818" y="2987900"/>
            <a:ext cx="1" cy="740004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C2CB0CA8-A548-4AF6-BE2D-D231E454B1AD}"/>
              </a:ext>
            </a:extLst>
          </p:cNvPr>
          <p:cNvSpPr txBox="1"/>
          <p:nvPr/>
        </p:nvSpPr>
        <p:spPr>
          <a:xfrm>
            <a:off x="3696279" y="3865784"/>
            <a:ext cx="2388474" cy="92333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ctual features that are</a:t>
            </a:r>
          </a:p>
          <a:p>
            <a:r>
              <a:rPr lang="en-US" dirty="0"/>
              <a:t>passed through all </a:t>
            </a:r>
          </a:p>
          <a:p>
            <a:r>
              <a:rPr lang="en-US" dirty="0"/>
              <a:t>pipeline steps</a:t>
            </a:r>
          </a:p>
        </p:txBody>
      </p:sp>
      <p:cxnSp>
        <p:nvCxnSpPr>
          <p:cNvPr id="56" name="Straight Arrow Connector 55">
            <a:extLst>
              <a:ext uri="{FF2B5EF4-FFF2-40B4-BE49-F238E27FC236}">
                <a16:creationId xmlns:a16="http://schemas.microsoft.com/office/drawing/2014/main" id="{6E263AA4-BC19-4A3D-BFC1-2B9D91DF95CD}"/>
              </a:ext>
            </a:extLst>
          </p:cNvPr>
          <p:cNvCxnSpPr>
            <a:stCxn id="35" idx="2"/>
          </p:cNvCxnSpPr>
          <p:nvPr/>
        </p:nvCxnSpPr>
        <p:spPr>
          <a:xfrm flipH="1">
            <a:off x="10953065" y="2987900"/>
            <a:ext cx="1" cy="61274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8D23E500-3A9F-426B-A27D-4BE8C9D77C0C}"/>
              </a:ext>
            </a:extLst>
          </p:cNvPr>
          <p:cNvCxnSpPr/>
          <p:nvPr/>
        </p:nvCxnSpPr>
        <p:spPr>
          <a:xfrm flipH="1">
            <a:off x="10192314" y="2988297"/>
            <a:ext cx="1" cy="612742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>
            <a:extLst>
              <a:ext uri="{FF2B5EF4-FFF2-40B4-BE49-F238E27FC236}">
                <a16:creationId xmlns:a16="http://schemas.microsoft.com/office/drawing/2014/main" id="{69D8DD5F-64E1-4499-B064-C7C51C317E82}"/>
              </a:ext>
            </a:extLst>
          </p:cNvPr>
          <p:cNvSpPr txBox="1"/>
          <p:nvPr/>
        </p:nvSpPr>
        <p:spPr>
          <a:xfrm>
            <a:off x="9714322" y="3525625"/>
            <a:ext cx="2654381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orange columns:</a:t>
            </a:r>
          </a:p>
          <a:p>
            <a:r>
              <a:rPr lang="en-US" dirty="0"/>
              <a:t>indicators of train/test</a:t>
            </a:r>
          </a:p>
          <a:p>
            <a:r>
              <a:rPr lang="en-US" dirty="0"/>
              <a:t>predefined splits, needed</a:t>
            </a:r>
          </a:p>
          <a:p>
            <a:r>
              <a:rPr lang="en-US" dirty="0"/>
              <a:t>by CV and the scorer,</a:t>
            </a:r>
          </a:p>
          <a:p>
            <a:r>
              <a:rPr lang="en-US" dirty="0"/>
              <a:t>to be passed along </a:t>
            </a:r>
          </a:p>
          <a:p>
            <a:r>
              <a:rPr lang="en-US" dirty="0"/>
              <a:t>UNCHANGED through the </a:t>
            </a:r>
          </a:p>
          <a:p>
            <a:r>
              <a:rPr lang="en-US" dirty="0"/>
              <a:t>pipeline steps till the end</a:t>
            </a:r>
          </a:p>
        </p:txBody>
      </p:sp>
      <p:cxnSp>
        <p:nvCxnSpPr>
          <p:cNvPr id="59" name="Straight Arrow Connector 58">
            <a:extLst>
              <a:ext uri="{FF2B5EF4-FFF2-40B4-BE49-F238E27FC236}">
                <a16:creationId xmlns:a16="http://schemas.microsoft.com/office/drawing/2014/main" id="{F229EE20-F900-44CA-908D-650DBF6DB4C7}"/>
              </a:ext>
            </a:extLst>
          </p:cNvPr>
          <p:cNvCxnSpPr>
            <a:cxnSpLocks/>
          </p:cNvCxnSpPr>
          <p:nvPr/>
        </p:nvCxnSpPr>
        <p:spPr>
          <a:xfrm>
            <a:off x="9245500" y="3026004"/>
            <a:ext cx="808" cy="190193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Straight Arrow Connector 59">
            <a:extLst>
              <a:ext uri="{FF2B5EF4-FFF2-40B4-BE49-F238E27FC236}">
                <a16:creationId xmlns:a16="http://schemas.microsoft.com/office/drawing/2014/main" id="{4D9DEB8D-969F-4DEA-A221-42247AAEAD34}"/>
              </a:ext>
            </a:extLst>
          </p:cNvPr>
          <p:cNvCxnSpPr>
            <a:cxnSpLocks/>
          </p:cNvCxnSpPr>
          <p:nvPr/>
        </p:nvCxnSpPr>
        <p:spPr>
          <a:xfrm>
            <a:off x="8484751" y="3026004"/>
            <a:ext cx="18028" cy="1901933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746B903F-145C-4719-A0C9-0231447B3E5A}"/>
              </a:ext>
            </a:extLst>
          </p:cNvPr>
          <p:cNvSpPr txBox="1"/>
          <p:nvPr/>
        </p:nvSpPr>
        <p:spPr>
          <a:xfrm>
            <a:off x="7116793" y="4886857"/>
            <a:ext cx="2605393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green columns:</a:t>
            </a:r>
          </a:p>
          <a:p>
            <a:r>
              <a:rPr lang="en-US" dirty="0"/>
              <a:t>pre-adjusted target</a:t>
            </a:r>
          </a:p>
          <a:p>
            <a:r>
              <a:rPr lang="en-US" dirty="0"/>
              <a:t>(one for each CV split)</a:t>
            </a:r>
          </a:p>
          <a:p>
            <a:r>
              <a:rPr lang="en-US" dirty="0"/>
              <a:t>needed by the scorer,</a:t>
            </a:r>
          </a:p>
          <a:p>
            <a:r>
              <a:rPr lang="en-US" dirty="0"/>
              <a:t>to be passed along </a:t>
            </a:r>
          </a:p>
          <a:p>
            <a:r>
              <a:rPr lang="en-US" dirty="0"/>
              <a:t>unchanged through the </a:t>
            </a:r>
          </a:p>
          <a:p>
            <a:r>
              <a:rPr lang="en-US" dirty="0"/>
              <a:t>pipeline steps till the end</a:t>
            </a:r>
          </a:p>
        </p:txBody>
      </p:sp>
      <p:cxnSp>
        <p:nvCxnSpPr>
          <p:cNvPr id="39" name="Straight Arrow Connector 38">
            <a:extLst>
              <a:ext uri="{FF2B5EF4-FFF2-40B4-BE49-F238E27FC236}">
                <a16:creationId xmlns:a16="http://schemas.microsoft.com/office/drawing/2014/main" id="{7AA672B7-C60D-4575-86C0-2F4ACFB505B6}"/>
              </a:ext>
            </a:extLst>
          </p:cNvPr>
          <p:cNvCxnSpPr>
            <a:cxnSpLocks/>
          </p:cNvCxnSpPr>
          <p:nvPr/>
        </p:nvCxnSpPr>
        <p:spPr>
          <a:xfrm>
            <a:off x="1602760" y="2998405"/>
            <a:ext cx="0" cy="602237"/>
          </a:xfrm>
          <a:prstGeom prst="straightConnector1">
            <a:avLst/>
          </a:prstGeom>
          <a:ln w="127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7884654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7</TotalTime>
  <Words>108</Words>
  <Application>Microsoft Office PowerPoint</Application>
  <PresentationFormat>Widescreen</PresentationFormat>
  <Paragraphs>2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nduchi</dc:creator>
  <cp:lastModifiedBy>manduchi</cp:lastModifiedBy>
  <cp:revision>36</cp:revision>
  <dcterms:created xsi:type="dcterms:W3CDTF">2020-04-03T17:45:15Z</dcterms:created>
  <dcterms:modified xsi:type="dcterms:W3CDTF">2020-09-02T20:17:46Z</dcterms:modified>
</cp:coreProperties>
</file>